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FB3380-3FFF-4EC3-A5D5-48FCBE54B6B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DE4595-019B-4826-B2FE-9E5E6E6D418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634F78-14A2-4112-94CF-FD9C83D7A6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2A699F2-4006-4D8F-8F8B-F5A8526E1BD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 rtl="1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325C0F-3940-4E3F-B8EE-222352B05C4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949963-E414-4C31-9D97-6B67361B10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4CA0D3-35C2-4336-A625-E419B3D95E8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65CD79-862E-4ECD-801B-7EED6BE8623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 rtl="1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13808B-940F-42F7-BEAA-9F18EF28DBE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B5693D9-FEE4-4D7B-8A47-CD82CD2E43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037D9A-F891-4347-9C00-A0AB65F609E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 algn="r" rtl="1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5B1112-B8E4-4D9B-8958-02FC67BD363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 algn="r" rtl="1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he-IL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he-IL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he-IL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rtl="1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2157B30-CCA9-42A1-8C1C-67893527D1F0}" type="slidenum">
              <a:rPr b="0" lang="he-IL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 flipH="1" rot="16200000">
            <a:off x="-785880" y="2456640"/>
            <a:ext cx="21816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 rtl="1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fdr transformed p-valu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"/>
          <p:cNvSpPr/>
          <p:nvPr/>
        </p:nvSpPr>
        <p:spPr>
          <a:xfrm>
            <a:off x="838080" y="5432400"/>
            <a:ext cx="8153640" cy="969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Figure S2. The genes selected for the genetic interaction screen with </a:t>
            </a:r>
            <a:r>
              <a:rPr b="1" i="1" lang="en-US" sz="1200" spc="-1" strike="noStrike">
                <a:solidFill>
                  <a:srgbClr val="000000"/>
                </a:solidFill>
                <a:latin typeface="Arial"/>
              </a:rPr>
              <a:t>Dlmo</a:t>
            </a:r>
            <a:r>
              <a:rPr b="1" i="1" lang="en-US" sz="1200" spc="-1" strike="noStrike" baseline="30000">
                <a:solidFill>
                  <a:srgbClr val="000000"/>
                </a:solidFill>
                <a:latin typeface="Arial"/>
              </a:rPr>
              <a:t>Bx2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are evenly distributed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2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Each gene is plotted against the fdr transformed p-value generated by the ANOVA based statistical test used to determine the statistically significant genes that are differentially expressed between </a:t>
            </a:r>
            <a:r>
              <a:rPr b="0" i="1" lang="en-US" sz="1200" spc="-1" strike="noStrike">
                <a:solidFill>
                  <a:srgbClr val="000000"/>
                </a:solidFill>
                <a:latin typeface="Arial"/>
              </a:rPr>
              <a:t>ssdp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trans-heteroallels and their corresponding heterozygotes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3" name="" descr=""/>
          <p:cNvPicPr/>
          <p:nvPr/>
        </p:nvPicPr>
        <p:blipFill>
          <a:blip r:embed="rId1"/>
          <a:stretch/>
        </p:blipFill>
        <p:spPr>
          <a:xfrm>
            <a:off x="466560" y="76320"/>
            <a:ext cx="8677440" cy="5410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1-28T13:42:58Z</dcterms:created>
  <dc:creator>Revital Bronstien</dc:creator>
  <dc:description/>
  <dc:language>en-US</dc:language>
  <cp:lastModifiedBy>Revital Bronstien</cp:lastModifiedBy>
  <dcterms:modified xsi:type="dcterms:W3CDTF">2010-06-28T08:06:05Z</dcterms:modified>
  <cp:revision>3</cp:revision>
  <dc:subject/>
  <dc:title>שקופית 1</dc:title>
</cp:coreProperties>
</file>